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16E9B1-C898-4A41-95CC-E0ECD0FC0AF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BB5FE9-003A-49C0-B0FA-E94972F860D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CDAB1B-6AB5-4AE3-BB57-99E261F37E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86CBC9-6B55-4E78-B019-69B4BAAE94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A1233B-CD3C-451E-9435-80EF8896261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8B46EB-0137-4F7F-8A8A-0571789813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330DB1-F417-4E25-A1E6-A7C9A4837D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A2C488-7AF6-4B5F-AAE0-53DD835974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0C3889-2EAE-445E-8603-F4D46AD36C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EF6A70-2A77-4DBB-9C89-543DB12618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891AD5-8631-4171-97C5-33AE2A3ED2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40EC8B-4170-4A52-950C-F428F0911B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125CB9-3149-4934-8A01-45585DD02D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03C38E-FD7D-40E7-A07A-35280E0E35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B1638D-2EC7-4C74-B2A3-2ADE64B4C75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4"/>
          <p:cNvSpPr/>
          <p:nvPr/>
        </p:nvSpPr>
        <p:spPr>
          <a:xfrm>
            <a:off x="1963080" y="735120"/>
            <a:ext cx="280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ample (dissected frozen brain regio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5"/>
          <p:cNvSpPr/>
          <p:nvPr/>
        </p:nvSpPr>
        <p:spPr>
          <a:xfrm>
            <a:off x="2358720" y="1341360"/>
            <a:ext cx="2142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NA extraction (total RN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QIAZOL and RNeasy mini ki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6"/>
          <p:cNvSpPr/>
          <p:nvPr/>
        </p:nvSpPr>
        <p:spPr>
          <a:xfrm>
            <a:off x="2562120" y="2765520"/>
            <a:ext cx="16239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everse transcrip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MMLV RT-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Random prim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7"/>
          <p:cNvSpPr/>
          <p:nvPr/>
        </p:nvSpPr>
        <p:spPr>
          <a:xfrm>
            <a:off x="1979640" y="3735360"/>
            <a:ext cx="27748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Q-PCR with gene-specific prim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Multiple reference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Genes of inter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0"/>
          <p:cNvSpPr/>
          <p:nvPr/>
        </p:nvSpPr>
        <p:spPr>
          <a:xfrm>
            <a:off x="2051280" y="5127480"/>
            <a:ext cx="265860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Data analysis using raw C</a:t>
            </a:r>
            <a:r>
              <a:rPr b="1" lang="en-GB" sz="1200" spc="-1" strike="noStrike" baseline="-25000">
                <a:solidFill>
                  <a:srgbClr val="000000"/>
                </a:solidFill>
                <a:latin typeface="Arial"/>
              </a:rPr>
              <a:t>t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value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1"/>
          <p:cNvSpPr/>
          <p:nvPr/>
        </p:nvSpPr>
        <p:spPr>
          <a:xfrm>
            <a:off x="1652760" y="2158920"/>
            <a:ext cx="342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NA quantification (Bioanalyse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2"/>
          <p:cNvSpPr/>
          <p:nvPr/>
        </p:nvSpPr>
        <p:spPr>
          <a:xfrm>
            <a:off x="1671480" y="5595840"/>
            <a:ext cx="3404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alculate geometric mean of 3 reference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3"/>
          <p:cNvSpPr/>
          <p:nvPr/>
        </p:nvSpPr>
        <p:spPr>
          <a:xfrm>
            <a:off x="1052640" y="7018200"/>
            <a:ext cx="4628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Express crossing threshold of each sample with respect to the least expressed sample for each gene of interes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4"/>
          <p:cNvSpPr/>
          <p:nvPr/>
        </p:nvSpPr>
        <p:spPr>
          <a:xfrm>
            <a:off x="765000" y="6188040"/>
            <a:ext cx="5185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Express crossing threshold of each sample with respect to the least expressed sample for the geometric mean of reference genes (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5"/>
          <p:cNvSpPr/>
          <p:nvPr/>
        </p:nvSpPr>
        <p:spPr>
          <a:xfrm>
            <a:off x="1638000" y="7792920"/>
            <a:ext cx="345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alculate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t (sample) –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t (reference) =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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6"/>
          <p:cNvSpPr/>
          <p:nvPr/>
        </p:nvSpPr>
        <p:spPr>
          <a:xfrm>
            <a:off x="1357920" y="8385120"/>
            <a:ext cx="40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alculate expression ratio according to the formula 2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r>
              <a:rPr b="0" lang="en-GB" sz="1200" spc="-1" strike="noStrike" baseline="30000">
                <a:solidFill>
                  <a:srgbClr val="000000"/>
                </a:solidFill>
                <a:latin typeface="Symbol"/>
                <a:ea typeface="Symbol"/>
              </a:rPr>
              <a:t>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Ct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7"/>
          <p:cNvSpPr/>
          <p:nvPr/>
        </p:nvSpPr>
        <p:spPr>
          <a:xfrm>
            <a:off x="3367080" y="103176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8"/>
          <p:cNvSpPr/>
          <p:nvPr/>
        </p:nvSpPr>
        <p:spPr>
          <a:xfrm>
            <a:off x="3367080" y="184932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2"/>
          <p:cNvSpPr/>
          <p:nvPr/>
        </p:nvSpPr>
        <p:spPr>
          <a:xfrm>
            <a:off x="3367080" y="245592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3"/>
          <p:cNvSpPr/>
          <p:nvPr/>
        </p:nvSpPr>
        <p:spPr>
          <a:xfrm>
            <a:off x="3367080" y="342576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25"/>
          <p:cNvSpPr/>
          <p:nvPr/>
        </p:nvSpPr>
        <p:spPr>
          <a:xfrm>
            <a:off x="3367080" y="588492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6"/>
          <p:cNvSpPr/>
          <p:nvPr/>
        </p:nvSpPr>
        <p:spPr>
          <a:xfrm>
            <a:off x="3367080" y="671508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7"/>
          <p:cNvSpPr/>
          <p:nvPr/>
        </p:nvSpPr>
        <p:spPr>
          <a:xfrm>
            <a:off x="3367080" y="748980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8"/>
          <p:cNvSpPr/>
          <p:nvPr/>
        </p:nvSpPr>
        <p:spPr>
          <a:xfrm>
            <a:off x="3367080" y="808200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9"/>
          <p:cNvSpPr/>
          <p:nvPr/>
        </p:nvSpPr>
        <p:spPr>
          <a:xfrm>
            <a:off x="2700720" y="285840"/>
            <a:ext cx="1334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Data gener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06T18:21:52Z</dcterms:created>
  <dc:creator>Neurogenetics</dc:creator>
  <dc:description/>
  <dc:language>en-US</dc:language>
  <cp:lastModifiedBy>bennc</cp:lastModifiedBy>
  <dcterms:modified xsi:type="dcterms:W3CDTF">2008-10-03T09:38:37Z</dcterms:modified>
  <cp:revision>12</cp:revision>
  <dc:subject/>
  <dc:title>Slide 1</dc:title>
</cp:coreProperties>
</file>